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revisionInfo.xml" ContentType="application/vnd.ms-powerpoint.revisioninfo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ngesInfos/changesInfo1.xml" ContentType="application/vnd.ms-powerpoint.changesinfo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99E1CAA-E79C-4B34-AE13-42B3F2A825DD}" v="6" dt="2021-07-20T10:14:12.09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 horzBarState="maximized">
    <p:restoredLeft sz="15993" autoAdjust="0"/>
    <p:restoredTop sz="94660"/>
  </p:normalViewPr>
  <p:slideViewPr>
    <p:cSldViewPr snapToGrid="0">
      <p:cViewPr varScale="1">
        <p:scale>
          <a:sx n="91" d="100"/>
          <a:sy n="91" d="100"/>
        </p:scale>
        <p:origin x="-534" y="-11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aul Jewell" userId="be134b94da70f434" providerId="LiveId" clId="{51D7DE33-4A4D-4421-B42E-2A918A6FCB5E}"/>
    <pc:docChg chg="modSld">
      <pc:chgData name="Paul Jewell" userId="be134b94da70f434" providerId="LiveId" clId="{51D7DE33-4A4D-4421-B42E-2A918A6FCB5E}" dt="2020-09-03T09:53:39.079" v="0" actId="113"/>
      <pc:docMkLst>
        <pc:docMk/>
      </pc:docMkLst>
      <pc:sldChg chg="modSp mod">
        <pc:chgData name="Paul Jewell" userId="be134b94da70f434" providerId="LiveId" clId="{51D7DE33-4A4D-4421-B42E-2A918A6FCB5E}" dt="2020-09-03T09:53:39.079" v="0" actId="113"/>
        <pc:sldMkLst>
          <pc:docMk/>
          <pc:sldMk cId="2614607501" sldId="256"/>
        </pc:sldMkLst>
        <pc:spChg chg="mod">
          <ac:chgData name="Paul Jewell" userId="be134b94da70f434" providerId="LiveId" clId="{51D7DE33-4A4D-4421-B42E-2A918A6FCB5E}" dt="2020-09-03T09:53:39.079" v="0" actId="113"/>
          <ac:spMkLst>
            <pc:docMk/>
            <pc:sldMk cId="2614607501" sldId="256"/>
            <ac:spMk id="6" creationId="{47C50B3B-C6E7-4682-9187-BF06369112FD}"/>
          </ac:spMkLst>
        </pc:spChg>
      </pc:sldChg>
    </pc:docChg>
  </pc:docChgLst>
  <pc:docChgLst>
    <pc:chgData name="Paul Jewell" userId="be134b94da70f434" providerId="LiveId" clId="{D6249D79-75DE-4B0E-BA7F-D3E450E820D9}"/>
    <pc:docChg chg="modSld">
      <pc:chgData name="Paul Jewell" userId="be134b94da70f434" providerId="LiveId" clId="{D6249D79-75DE-4B0E-BA7F-D3E450E820D9}" dt="2021-01-05T21:19:11.411" v="145" actId="20577"/>
      <pc:docMkLst>
        <pc:docMk/>
      </pc:docMkLst>
      <pc:sldChg chg="modSp mod">
        <pc:chgData name="Paul Jewell" userId="be134b94da70f434" providerId="LiveId" clId="{D6249D79-75DE-4B0E-BA7F-D3E450E820D9}" dt="2021-01-05T21:19:11.411" v="145" actId="20577"/>
        <pc:sldMkLst>
          <pc:docMk/>
          <pc:sldMk cId="2614607501" sldId="256"/>
        </pc:sldMkLst>
        <pc:spChg chg="mod">
          <ac:chgData name="Paul Jewell" userId="be134b94da70f434" providerId="LiveId" clId="{D6249D79-75DE-4B0E-BA7F-D3E450E820D9}" dt="2021-01-05T21:19:11.411" v="145" actId="20577"/>
          <ac:spMkLst>
            <pc:docMk/>
            <pc:sldMk cId="2614607501" sldId="256"/>
            <ac:spMk id="4" creationId="{D13C00AC-CAE9-4692-8068-E0E1F83826C0}"/>
          </ac:spMkLst>
        </pc:spChg>
        <pc:spChg chg="mod">
          <ac:chgData name="Paul Jewell" userId="be134b94da70f434" providerId="LiveId" clId="{D6249D79-75DE-4B0E-BA7F-D3E450E820D9}" dt="2021-01-05T21:17:38.969" v="109" actId="20577"/>
          <ac:spMkLst>
            <pc:docMk/>
            <pc:sldMk cId="2614607501" sldId="256"/>
            <ac:spMk id="6" creationId="{47C50B3B-C6E7-4682-9187-BF06369112FD}"/>
          </ac:spMkLst>
        </pc:spChg>
        <pc:spChg chg="mod">
          <ac:chgData name="Paul Jewell" userId="be134b94da70f434" providerId="LiveId" clId="{D6249D79-75DE-4B0E-BA7F-D3E450E820D9}" dt="2021-01-05T21:18:26.717" v="125" actId="1076"/>
          <ac:spMkLst>
            <pc:docMk/>
            <pc:sldMk cId="2614607501" sldId="256"/>
            <ac:spMk id="8" creationId="{01A2F1C9-C8D2-4EA3-8FBD-1B34ED3647A0}"/>
          </ac:spMkLst>
        </pc:spChg>
        <pc:spChg chg="mod">
          <ac:chgData name="Paul Jewell" userId="be134b94da70f434" providerId="LiveId" clId="{D6249D79-75DE-4B0E-BA7F-D3E450E820D9}" dt="2021-01-05T21:18:18.652" v="123" actId="1076"/>
          <ac:spMkLst>
            <pc:docMk/>
            <pc:sldMk cId="2614607501" sldId="256"/>
            <ac:spMk id="10" creationId="{2C8A4A11-1E53-450C-8039-F206ADDDEE1D}"/>
          </ac:spMkLst>
        </pc:spChg>
        <pc:spChg chg="mod">
          <ac:chgData name="Paul Jewell" userId="be134b94da70f434" providerId="LiveId" clId="{D6249D79-75DE-4B0E-BA7F-D3E450E820D9}" dt="2021-01-05T21:18:52.900" v="144" actId="20577"/>
          <ac:spMkLst>
            <pc:docMk/>
            <pc:sldMk cId="2614607501" sldId="256"/>
            <ac:spMk id="12" creationId="{10C2C343-390F-4535-87C8-9D67240F775F}"/>
          </ac:spMkLst>
        </pc:spChg>
        <pc:cxnChg chg="mod">
          <ac:chgData name="Paul Jewell" userId="be134b94da70f434" providerId="LiveId" clId="{D6249D79-75DE-4B0E-BA7F-D3E450E820D9}" dt="2021-01-05T21:18:43.763" v="128" actId="1076"/>
          <ac:cxnSpMkLst>
            <pc:docMk/>
            <pc:sldMk cId="2614607501" sldId="256"/>
            <ac:cxnSpMk id="14" creationId="{4951B135-D2FA-4DE6-A6A1-67A2FE079F9C}"/>
          </ac:cxnSpMkLst>
        </pc:cxnChg>
        <pc:cxnChg chg="mod">
          <ac:chgData name="Paul Jewell" userId="be134b94da70f434" providerId="LiveId" clId="{D6249D79-75DE-4B0E-BA7F-D3E450E820D9}" dt="2021-01-05T21:18:36.609" v="127" actId="14100"/>
          <ac:cxnSpMkLst>
            <pc:docMk/>
            <pc:sldMk cId="2614607501" sldId="256"/>
            <ac:cxnSpMk id="16" creationId="{E51F1121-6743-49C3-9503-A103FE9C6F41}"/>
          </ac:cxnSpMkLst>
        </pc:cxnChg>
        <pc:cxnChg chg="mod">
          <ac:chgData name="Paul Jewell" userId="be134b94da70f434" providerId="LiveId" clId="{D6249D79-75DE-4B0E-BA7F-D3E450E820D9}" dt="2021-01-05T21:18:43.763" v="128" actId="1076"/>
          <ac:cxnSpMkLst>
            <pc:docMk/>
            <pc:sldMk cId="2614607501" sldId="256"/>
            <ac:cxnSpMk id="17" creationId="{080FD168-5230-4DAA-ACF7-8859A94D0E5A}"/>
          </ac:cxnSpMkLst>
        </pc:cxnChg>
        <pc:cxnChg chg="mod">
          <ac:chgData name="Paul Jewell" userId="be134b94da70f434" providerId="LiveId" clId="{D6249D79-75DE-4B0E-BA7F-D3E450E820D9}" dt="2021-01-05T21:18:22.082" v="124" actId="14100"/>
          <ac:cxnSpMkLst>
            <pc:docMk/>
            <pc:sldMk cId="2614607501" sldId="256"/>
            <ac:cxnSpMk id="20" creationId="{A1DA6BE7-1418-406B-B992-BBAD006888EE}"/>
          </ac:cxnSpMkLst>
        </pc:cxnChg>
      </pc:sldChg>
    </pc:docChg>
  </pc:docChgLst>
  <pc:docChgLst>
    <pc:chgData name="Paul Jewell" userId="be134b94da70f434" providerId="LiveId" clId="{E99E1CAA-E79C-4B34-AE13-42B3F2A825DD}"/>
    <pc:docChg chg="custSel addSld modSld">
      <pc:chgData name="Paul Jewell" userId="be134b94da70f434" providerId="LiveId" clId="{E99E1CAA-E79C-4B34-AE13-42B3F2A825DD}" dt="2021-07-20T10:16:43.761" v="82" actId="1076"/>
      <pc:docMkLst>
        <pc:docMk/>
      </pc:docMkLst>
      <pc:sldChg chg="addSp delSp modSp mod">
        <pc:chgData name="Paul Jewell" userId="be134b94da70f434" providerId="LiveId" clId="{E99E1CAA-E79C-4B34-AE13-42B3F2A825DD}" dt="2021-07-20T10:12:51.792" v="68"/>
        <pc:sldMkLst>
          <pc:docMk/>
          <pc:sldMk cId="2614607501" sldId="256"/>
        </pc:sldMkLst>
        <pc:spChg chg="mod">
          <ac:chgData name="Paul Jewell" userId="be134b94da70f434" providerId="LiveId" clId="{E99E1CAA-E79C-4B34-AE13-42B3F2A825DD}" dt="2021-07-20T10:11:05.932" v="29" actId="20577"/>
          <ac:spMkLst>
            <pc:docMk/>
            <pc:sldMk cId="2614607501" sldId="256"/>
            <ac:spMk id="4" creationId="{D13C00AC-CAE9-4692-8068-E0E1F83826C0}"/>
          </ac:spMkLst>
        </pc:spChg>
        <pc:spChg chg="mod">
          <ac:chgData name="Paul Jewell" userId="be134b94da70f434" providerId="LiveId" clId="{E99E1CAA-E79C-4B34-AE13-42B3F2A825DD}" dt="2021-07-20T10:11:44.998" v="65" actId="1076"/>
          <ac:spMkLst>
            <pc:docMk/>
            <pc:sldMk cId="2614607501" sldId="256"/>
            <ac:spMk id="8" creationId="{01A2F1C9-C8D2-4EA3-8FBD-1B34ED3647A0}"/>
          </ac:spMkLst>
        </pc:spChg>
        <pc:spChg chg="add del mod">
          <ac:chgData name="Paul Jewell" userId="be134b94da70f434" providerId="LiveId" clId="{E99E1CAA-E79C-4B34-AE13-42B3F2A825DD}" dt="2021-07-20T10:12:51.792" v="68"/>
          <ac:spMkLst>
            <pc:docMk/>
            <pc:sldMk cId="2614607501" sldId="256"/>
            <ac:spMk id="13" creationId="{0B6E2DAE-1BF5-4789-9254-0F35955B2548}"/>
          </ac:spMkLst>
        </pc:spChg>
        <pc:spChg chg="add del mod">
          <ac:chgData name="Paul Jewell" userId="be134b94da70f434" providerId="LiveId" clId="{E99E1CAA-E79C-4B34-AE13-42B3F2A825DD}" dt="2021-07-20T10:12:51.792" v="68"/>
          <ac:spMkLst>
            <pc:docMk/>
            <pc:sldMk cId="2614607501" sldId="256"/>
            <ac:spMk id="15" creationId="{207137BF-E3F1-4465-9733-796EDCA868DC}"/>
          </ac:spMkLst>
        </pc:spChg>
        <pc:spChg chg="add del mod">
          <ac:chgData name="Paul Jewell" userId="be134b94da70f434" providerId="LiveId" clId="{E99E1CAA-E79C-4B34-AE13-42B3F2A825DD}" dt="2021-07-20T10:12:51.792" v="68"/>
          <ac:spMkLst>
            <pc:docMk/>
            <pc:sldMk cId="2614607501" sldId="256"/>
            <ac:spMk id="18" creationId="{553BE5BC-8AB5-43AD-AA85-894264A5B21F}"/>
          </ac:spMkLst>
        </pc:spChg>
        <pc:spChg chg="add del mod">
          <ac:chgData name="Paul Jewell" userId="be134b94da70f434" providerId="LiveId" clId="{E99E1CAA-E79C-4B34-AE13-42B3F2A825DD}" dt="2021-07-20T10:12:51.792" v="68"/>
          <ac:spMkLst>
            <pc:docMk/>
            <pc:sldMk cId="2614607501" sldId="256"/>
            <ac:spMk id="19" creationId="{8CCA0861-57C7-4C90-9239-3D1740C90E4E}"/>
          </ac:spMkLst>
        </pc:spChg>
        <pc:spChg chg="add del mod">
          <ac:chgData name="Paul Jewell" userId="be134b94da70f434" providerId="LiveId" clId="{E99E1CAA-E79C-4B34-AE13-42B3F2A825DD}" dt="2021-07-20T10:12:51.792" v="68"/>
          <ac:spMkLst>
            <pc:docMk/>
            <pc:sldMk cId="2614607501" sldId="256"/>
            <ac:spMk id="21" creationId="{84988DA5-CE01-4FD6-9317-76AE38C7B06D}"/>
          </ac:spMkLst>
        </pc:spChg>
        <pc:cxnChg chg="mod">
          <ac:chgData name="Paul Jewell" userId="be134b94da70f434" providerId="LiveId" clId="{E99E1CAA-E79C-4B34-AE13-42B3F2A825DD}" dt="2021-07-20T10:11:46.852" v="66" actId="14100"/>
          <ac:cxnSpMkLst>
            <pc:docMk/>
            <pc:sldMk cId="2614607501" sldId="256"/>
            <ac:cxnSpMk id="16" creationId="{E51F1121-6743-49C3-9503-A103FE9C6F41}"/>
          </ac:cxnSpMkLst>
        </pc:cxnChg>
        <pc:cxnChg chg="add del mod">
          <ac:chgData name="Paul Jewell" userId="be134b94da70f434" providerId="LiveId" clId="{E99E1CAA-E79C-4B34-AE13-42B3F2A825DD}" dt="2021-07-20T10:12:51.792" v="68"/>
          <ac:cxnSpMkLst>
            <pc:docMk/>
            <pc:sldMk cId="2614607501" sldId="256"/>
            <ac:cxnSpMk id="22" creationId="{B6114A99-2B23-4964-AAED-E728B45FC8BC}"/>
          </ac:cxnSpMkLst>
        </pc:cxnChg>
        <pc:cxnChg chg="add del mod">
          <ac:chgData name="Paul Jewell" userId="be134b94da70f434" providerId="LiveId" clId="{E99E1CAA-E79C-4B34-AE13-42B3F2A825DD}" dt="2021-07-20T10:12:51.792" v="68"/>
          <ac:cxnSpMkLst>
            <pc:docMk/>
            <pc:sldMk cId="2614607501" sldId="256"/>
            <ac:cxnSpMk id="23" creationId="{D0A02401-48DC-4B3F-92B2-9ED267ED40A5}"/>
          </ac:cxnSpMkLst>
        </pc:cxnChg>
        <pc:cxnChg chg="add del mod">
          <ac:chgData name="Paul Jewell" userId="be134b94da70f434" providerId="LiveId" clId="{E99E1CAA-E79C-4B34-AE13-42B3F2A825DD}" dt="2021-07-20T10:12:51.792" v="68"/>
          <ac:cxnSpMkLst>
            <pc:docMk/>
            <pc:sldMk cId="2614607501" sldId="256"/>
            <ac:cxnSpMk id="24" creationId="{96AEF71E-EFD9-4CA5-BBEC-2A36874C2C11}"/>
          </ac:cxnSpMkLst>
        </pc:cxnChg>
        <pc:cxnChg chg="add del mod">
          <ac:chgData name="Paul Jewell" userId="be134b94da70f434" providerId="LiveId" clId="{E99E1CAA-E79C-4B34-AE13-42B3F2A825DD}" dt="2021-07-20T10:12:51.792" v="68"/>
          <ac:cxnSpMkLst>
            <pc:docMk/>
            <pc:sldMk cId="2614607501" sldId="256"/>
            <ac:cxnSpMk id="25" creationId="{125C612C-C729-404C-9A65-359D3D8C3AA4}"/>
          </ac:cxnSpMkLst>
        </pc:cxnChg>
      </pc:sldChg>
      <pc:sldChg chg="addSp delSp modSp new mod">
        <pc:chgData name="Paul Jewell" userId="be134b94da70f434" providerId="LiveId" clId="{E99E1CAA-E79C-4B34-AE13-42B3F2A825DD}" dt="2021-07-20T10:16:43.761" v="82" actId="1076"/>
        <pc:sldMkLst>
          <pc:docMk/>
          <pc:sldMk cId="2105729647" sldId="257"/>
        </pc:sldMkLst>
        <pc:spChg chg="del">
          <ac:chgData name="Paul Jewell" userId="be134b94da70f434" providerId="LiveId" clId="{E99E1CAA-E79C-4B34-AE13-42B3F2A825DD}" dt="2021-07-20T10:14:28.620" v="79" actId="478"/>
          <ac:spMkLst>
            <pc:docMk/>
            <pc:sldMk cId="2105729647" sldId="257"/>
            <ac:spMk id="2" creationId="{B934D23E-8272-434C-BD05-6B2ECA3D8CB5}"/>
          </ac:spMkLst>
        </pc:spChg>
        <pc:spChg chg="del">
          <ac:chgData name="Paul Jewell" userId="be134b94da70f434" providerId="LiveId" clId="{E99E1CAA-E79C-4B34-AE13-42B3F2A825DD}" dt="2021-07-20T10:14:30.664" v="81" actId="478"/>
          <ac:spMkLst>
            <pc:docMk/>
            <pc:sldMk cId="2105729647" sldId="257"/>
            <ac:spMk id="3" creationId="{A033BEA7-2E9F-47CF-B914-2446FA092557}"/>
          </ac:spMkLst>
        </pc:spChg>
        <pc:spChg chg="add del mod">
          <ac:chgData name="Paul Jewell" userId="be134b94da70f434" providerId="LiveId" clId="{E99E1CAA-E79C-4B34-AE13-42B3F2A825DD}" dt="2021-07-20T10:12:57.224" v="71"/>
          <ac:spMkLst>
            <pc:docMk/>
            <pc:sldMk cId="2105729647" sldId="257"/>
            <ac:spMk id="4" creationId="{3302AE87-6BC4-4780-98B7-B9EF216E9B90}"/>
          </ac:spMkLst>
        </pc:spChg>
        <pc:spChg chg="add del mod">
          <ac:chgData name="Paul Jewell" userId="be134b94da70f434" providerId="LiveId" clId="{E99E1CAA-E79C-4B34-AE13-42B3F2A825DD}" dt="2021-07-20T10:12:57.224" v="71"/>
          <ac:spMkLst>
            <pc:docMk/>
            <pc:sldMk cId="2105729647" sldId="257"/>
            <ac:spMk id="5" creationId="{EEFAE7E3-C3F6-4D74-B8F1-AD518FD3598C}"/>
          </ac:spMkLst>
        </pc:spChg>
        <pc:spChg chg="add del mod">
          <ac:chgData name="Paul Jewell" userId="be134b94da70f434" providerId="LiveId" clId="{E99E1CAA-E79C-4B34-AE13-42B3F2A825DD}" dt="2021-07-20T10:12:57.224" v="71"/>
          <ac:spMkLst>
            <pc:docMk/>
            <pc:sldMk cId="2105729647" sldId="257"/>
            <ac:spMk id="6" creationId="{CCC4F107-D4CF-4305-8564-6FC3BC51EE2F}"/>
          </ac:spMkLst>
        </pc:spChg>
        <pc:spChg chg="add del mod">
          <ac:chgData name="Paul Jewell" userId="be134b94da70f434" providerId="LiveId" clId="{E99E1CAA-E79C-4B34-AE13-42B3F2A825DD}" dt="2021-07-20T10:12:57.224" v="71"/>
          <ac:spMkLst>
            <pc:docMk/>
            <pc:sldMk cId="2105729647" sldId="257"/>
            <ac:spMk id="7" creationId="{F171454D-39EB-4ED6-BBBE-C1B81DB297B5}"/>
          </ac:spMkLst>
        </pc:spChg>
        <pc:spChg chg="add del mod">
          <ac:chgData name="Paul Jewell" userId="be134b94da70f434" providerId="LiveId" clId="{E99E1CAA-E79C-4B34-AE13-42B3F2A825DD}" dt="2021-07-20T10:12:57.224" v="71"/>
          <ac:spMkLst>
            <pc:docMk/>
            <pc:sldMk cId="2105729647" sldId="257"/>
            <ac:spMk id="8" creationId="{DEC7EC96-C13A-4A65-99D4-110F7F13E1BA}"/>
          </ac:spMkLst>
        </pc:spChg>
        <pc:picChg chg="add mod">
          <ac:chgData name="Paul Jewell" userId="be134b94da70f434" providerId="LiveId" clId="{E99E1CAA-E79C-4B34-AE13-42B3F2A825DD}" dt="2021-07-20T10:16:43.761" v="82" actId="1076"/>
          <ac:picMkLst>
            <pc:docMk/>
            <pc:sldMk cId="2105729647" sldId="257"/>
            <ac:picMk id="13" creationId="{44555128-38D3-4C7B-87B3-CC7F6DCD21D4}"/>
          </ac:picMkLst>
        </pc:picChg>
        <pc:picChg chg="add del mod">
          <ac:chgData name="Paul Jewell" userId="be134b94da70f434" providerId="LiveId" clId="{E99E1CAA-E79C-4B34-AE13-42B3F2A825DD}" dt="2021-07-20T10:14:29.746" v="80" actId="478"/>
          <ac:picMkLst>
            <pc:docMk/>
            <pc:sldMk cId="2105729647" sldId="257"/>
            <ac:picMk id="14" creationId="{1158B77D-6ED5-4D0D-952D-2BD5AAED22F7}"/>
          </ac:picMkLst>
        </pc:picChg>
        <pc:cxnChg chg="add del mod">
          <ac:chgData name="Paul Jewell" userId="be134b94da70f434" providerId="LiveId" clId="{E99E1CAA-E79C-4B34-AE13-42B3F2A825DD}" dt="2021-07-20T10:12:57.224" v="71"/>
          <ac:cxnSpMkLst>
            <pc:docMk/>
            <pc:sldMk cId="2105729647" sldId="257"/>
            <ac:cxnSpMk id="9" creationId="{891E4419-BC8D-488B-8750-92C8761064C6}"/>
          </ac:cxnSpMkLst>
        </pc:cxnChg>
        <pc:cxnChg chg="add del mod">
          <ac:chgData name="Paul Jewell" userId="be134b94da70f434" providerId="LiveId" clId="{E99E1CAA-E79C-4B34-AE13-42B3F2A825DD}" dt="2021-07-20T10:12:57.224" v="71"/>
          <ac:cxnSpMkLst>
            <pc:docMk/>
            <pc:sldMk cId="2105729647" sldId="257"/>
            <ac:cxnSpMk id="10" creationId="{2E953B24-A62D-40A9-827F-DE6027A636D9}"/>
          </ac:cxnSpMkLst>
        </pc:cxnChg>
        <pc:cxnChg chg="add del mod">
          <ac:chgData name="Paul Jewell" userId="be134b94da70f434" providerId="LiveId" clId="{E99E1CAA-E79C-4B34-AE13-42B3F2A825DD}" dt="2021-07-20T10:12:57.224" v="71"/>
          <ac:cxnSpMkLst>
            <pc:docMk/>
            <pc:sldMk cId="2105729647" sldId="257"/>
            <ac:cxnSpMk id="11" creationId="{754DB984-6914-4E69-915B-7739FE9C3425}"/>
          </ac:cxnSpMkLst>
        </pc:cxnChg>
        <pc:cxnChg chg="add del mod">
          <ac:chgData name="Paul Jewell" userId="be134b94da70f434" providerId="LiveId" clId="{E99E1CAA-E79C-4B34-AE13-42B3F2A825DD}" dt="2021-07-20T10:12:57.224" v="71"/>
          <ac:cxnSpMkLst>
            <pc:docMk/>
            <pc:sldMk cId="2105729647" sldId="257"/>
            <ac:cxnSpMk id="12" creationId="{6CB5997A-B5E9-4B9C-98FD-4D76D86CA746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4619E699-5130-4917-9B3F-CD6D273C99C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="" xmlns:a16="http://schemas.microsoft.com/office/drawing/2014/main" id="{78EB68B9-131B-471E-9068-D2CAE335A5F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7EB6E466-8897-4B99-9E6A-5F7C1B3D97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94CC5-43F3-4203-A78D-62D35FFE702E}" type="datetimeFigureOut">
              <a:rPr lang="en-GB" smtClean="0"/>
              <a:pPr/>
              <a:t>23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19FD3738-1B30-4641-B781-38BBD119C8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F2B418B5-E9EB-449E-A385-298F817001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AC072-5154-4251-8304-D80CF403AB6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6577503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A9BAA62B-95B3-4E0E-9705-A072B5BDFD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87E23A51-B99D-4FD3-9A1F-08A6AC4CE8E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7EB77B26-A795-4431-88C8-63615B40D8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94CC5-43F3-4203-A78D-62D35FFE702E}" type="datetimeFigureOut">
              <a:rPr lang="en-GB" smtClean="0"/>
              <a:pPr/>
              <a:t>23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88559BEC-CCA9-442B-A13D-E3A3B62CD1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CF7B602A-0711-4F51-BAC5-6BFDDD21AD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AC072-5154-4251-8304-D80CF403AB6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6845574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="" xmlns:a16="http://schemas.microsoft.com/office/drawing/2014/main" id="{46933EDD-F9A5-4F46-88B1-A5F000F67C4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901CEDBC-FCD0-4833-81CE-33507ACFD4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508CB9A4-7B21-4DE2-A32F-3B09D45600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94CC5-43F3-4203-A78D-62D35FFE702E}" type="datetimeFigureOut">
              <a:rPr lang="en-GB" smtClean="0"/>
              <a:pPr/>
              <a:t>23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A25FB455-F510-4125-8E14-FEFEB3448C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CF88893E-2AEC-4C9E-BB8D-D39EB04FEA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AC072-5154-4251-8304-D80CF403AB6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9824830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FEF191D9-EE01-43D1-93DF-BC393A2C5A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5B7797A4-A55C-446A-8D82-4A36B4C292C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6F12779D-506C-4C0C-A1C5-D8A71119A2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94CC5-43F3-4203-A78D-62D35FFE702E}" type="datetimeFigureOut">
              <a:rPr lang="en-GB" smtClean="0"/>
              <a:pPr/>
              <a:t>23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377CB140-1CD0-49ED-B75A-CBF210E732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FD98FCFB-3BE8-4C0D-9096-0B4A1C774F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AC072-5154-4251-8304-D80CF403AB6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6511022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1E2DA3AF-0A0E-4325-B2ED-E2B00EFF3C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BCF686C9-81B0-42C5-8C12-019E4DBDC1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094BA71F-A227-41F5-8ECF-836A777A18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94CC5-43F3-4203-A78D-62D35FFE702E}" type="datetimeFigureOut">
              <a:rPr lang="en-GB" smtClean="0"/>
              <a:pPr/>
              <a:t>23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6212178E-0EF4-4D08-9A1C-CB94D2964B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629320A1-9965-498E-9230-5393273F14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AC072-5154-4251-8304-D80CF403AB6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6012405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3791A327-9366-41A7-B51E-BCDFA2375E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5748187C-A9C2-4F48-A838-A6ABB733E22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5DC063CE-E1BE-4097-A070-852CBCA372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7FC52E16-3C5E-4A35-83DA-F4AA2E31F6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94CC5-43F3-4203-A78D-62D35FFE702E}" type="datetimeFigureOut">
              <a:rPr lang="en-GB" smtClean="0"/>
              <a:pPr/>
              <a:t>23/07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8C4E8AA9-E8D7-42C8-A8A2-034F75A432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9E10A858-1C68-4CC8-AD21-4A65D255F4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AC072-5154-4251-8304-D80CF403AB6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6798920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F0979345-B6EB-4A1F-B258-C6FDB3AC44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2FA15176-E3A8-4FF0-A6ED-E7AA04C549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F8AB9C06-E2A2-47E5-9245-E54005928D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="" xmlns:a16="http://schemas.microsoft.com/office/drawing/2014/main" id="{2AD7150C-0006-49E8-85FE-60B30658C98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="" xmlns:a16="http://schemas.microsoft.com/office/drawing/2014/main" id="{233E6438-D491-43F0-8825-72A8A28406E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="" xmlns:a16="http://schemas.microsoft.com/office/drawing/2014/main" id="{7B5E6227-2CF9-4763-AF12-1659E4F906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94CC5-43F3-4203-A78D-62D35FFE702E}" type="datetimeFigureOut">
              <a:rPr lang="en-GB" smtClean="0"/>
              <a:pPr/>
              <a:t>23/07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="" xmlns:a16="http://schemas.microsoft.com/office/drawing/2014/main" id="{79C484A0-7CF4-4991-9590-25537242A1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="" xmlns:a16="http://schemas.microsoft.com/office/drawing/2014/main" id="{5B58F6A0-FF0F-4D64-8B44-67B29B299C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AC072-5154-4251-8304-D80CF403AB6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17478515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0970B404-3D74-4293-A869-43B744C5B3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="" xmlns:a16="http://schemas.microsoft.com/office/drawing/2014/main" id="{8E85CF7C-9B12-4C6F-BE49-C56600D4CD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94CC5-43F3-4203-A78D-62D35FFE702E}" type="datetimeFigureOut">
              <a:rPr lang="en-GB" smtClean="0"/>
              <a:pPr/>
              <a:t>23/07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="" xmlns:a16="http://schemas.microsoft.com/office/drawing/2014/main" id="{4EB500F8-ECCB-4A81-AD1C-F103851E9C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="" xmlns:a16="http://schemas.microsoft.com/office/drawing/2014/main" id="{9A1D9197-169E-412E-815D-858AD49BC4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AC072-5154-4251-8304-D80CF403AB6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4536370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="" xmlns:a16="http://schemas.microsoft.com/office/drawing/2014/main" id="{2352EC3F-3CD9-42DD-9A8A-5B62D73009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94CC5-43F3-4203-A78D-62D35FFE702E}" type="datetimeFigureOut">
              <a:rPr lang="en-GB" smtClean="0"/>
              <a:pPr/>
              <a:t>23/07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="" xmlns:a16="http://schemas.microsoft.com/office/drawing/2014/main" id="{B005E385-EA42-459B-BB68-34D6572D12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="" xmlns:a16="http://schemas.microsoft.com/office/drawing/2014/main" id="{33185E47-A853-4BFC-9B73-A706ACD61E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AC072-5154-4251-8304-D80CF403AB6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41968089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052D4801-4A07-4FFD-9B14-BB14C8F21C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2A13B3BD-2C25-4C7F-9709-F470C7391D9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B26F4513-8A43-4C18-9495-E2C057F6AB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8DE08B1A-6F53-470B-9DD2-3A69360918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94CC5-43F3-4203-A78D-62D35FFE702E}" type="datetimeFigureOut">
              <a:rPr lang="en-GB" smtClean="0"/>
              <a:pPr/>
              <a:t>23/07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21B3B6F4-5382-4100-8E6B-EC38810208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2678D385-0C2B-4F9B-B70B-3B03CBBF51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AC072-5154-4251-8304-D80CF403AB6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7102096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15073CA6-AD90-4F02-AFD1-06D6E27982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="" xmlns:a16="http://schemas.microsoft.com/office/drawing/2014/main" id="{EF5C7051-3B5D-4508-9426-EB6C90A9A06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6FDD0056-CB8F-4DA0-854E-A472E4BD67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FCA1D0E0-51D5-4727-9FD8-3C50FE03B5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94CC5-43F3-4203-A78D-62D35FFE702E}" type="datetimeFigureOut">
              <a:rPr lang="en-GB" smtClean="0"/>
              <a:pPr/>
              <a:t>23/07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41A14C06-800F-4A91-A95E-8C82F61B86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78578A6C-3134-4D3D-9FF8-34B8A685AB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AC072-5154-4251-8304-D80CF403AB6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16171744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="" xmlns:a16="http://schemas.microsoft.com/office/drawing/2014/main" id="{A97F9278-82B5-4D88-8BD1-8412A57D6B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3538A964-41CC-4956-81A1-15EB87C25A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17B5F0E1-358F-4C8B-B5AC-5E0F81FA95D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B94CC5-43F3-4203-A78D-62D35FFE702E}" type="datetimeFigureOut">
              <a:rPr lang="en-GB" smtClean="0"/>
              <a:pPr/>
              <a:t>23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B75774D2-291E-4865-96B5-6E0394F14EF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13D7CE2F-BC52-46F1-8EE6-999639FD633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DAC072-5154-4251-8304-D80CF403AB6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10993867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="" xmlns:a16="http://schemas.microsoft.com/office/drawing/2014/main" id="{44555128-38D3-4C7B-87B3-CC7F6DCD21D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07103" y="666125"/>
            <a:ext cx="4102964" cy="4919898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4183117" y="5934670"/>
            <a:ext cx="663202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ESRD: end stage renal disease</a:t>
            </a:r>
            <a:endParaRPr lang="en-US" sz="1200" dirty="0" smtClean="0"/>
          </a:p>
          <a:p>
            <a:r>
              <a:rPr lang="en-GB" sz="1200" dirty="0" smtClean="0"/>
              <a:t>RRT: renal replacement therapy</a:t>
            </a:r>
            <a:endParaRPr lang="en-US" sz="1200" dirty="0" smtClean="0"/>
          </a:p>
          <a:p>
            <a:r>
              <a:rPr lang="en-GB" sz="1200" dirty="0" smtClean="0"/>
              <a:t>*RRT includes haemodialysis, peritoneal dialysis and functioning renal transplants</a:t>
            </a:r>
            <a:endParaRPr lang="en-US" sz="1200" dirty="0" smtClean="0"/>
          </a:p>
          <a:p>
            <a:endParaRPr lang="en-US" dirty="0"/>
          </a:p>
        </p:txBody>
      </p:sp>
    </p:spTree>
    <p:extLst>
      <p:ext uri="{BB962C8B-B14F-4D97-AF65-F5344CB8AC3E}">
        <p14:creationId xmlns="" xmlns:p14="http://schemas.microsoft.com/office/powerpoint/2010/main" val="21057296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22</Words>
  <Application>Microsoft Office PowerPoint</Application>
  <PresentationFormat>Custom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 Jewell</dc:creator>
  <cp:lastModifiedBy>user</cp:lastModifiedBy>
  <cp:revision>4</cp:revision>
  <dcterms:created xsi:type="dcterms:W3CDTF">2020-09-03T09:39:57Z</dcterms:created>
  <dcterms:modified xsi:type="dcterms:W3CDTF">2021-07-23T12:46:46Z</dcterms:modified>
</cp:coreProperties>
</file>